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7E05BF1-38D5-4E57-B818-1AB9576200BB}" v="9" dt="2023-07-19T10:01:10.5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30" autoAdjust="0"/>
    <p:restoredTop sz="94660"/>
  </p:normalViewPr>
  <p:slideViewPr>
    <p:cSldViewPr snapToGrid="0">
      <p:cViewPr varScale="1">
        <p:scale>
          <a:sx n="62" d="100"/>
          <a:sy n="62" d="100"/>
        </p:scale>
        <p:origin x="84" y="7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E7E05BF1-38D5-4E57-B818-1AB9576200BB}"/>
    <pc:docChg chg="custSel addSld modSld">
      <pc:chgData name="JUAN MANUEL LOZANO GIL" userId="618ed11e-cb2c-4b03-8ac9-a8cf52f924c9" providerId="ADAL" clId="{E7E05BF1-38D5-4E57-B818-1AB9576200BB}" dt="2023-07-19T10:01:14.163" v="44" actId="1076"/>
      <pc:docMkLst>
        <pc:docMk/>
      </pc:docMkLst>
      <pc:sldChg chg="addSp delSp modSp mod">
        <pc:chgData name="JUAN MANUEL LOZANO GIL" userId="618ed11e-cb2c-4b03-8ac9-a8cf52f924c9" providerId="ADAL" clId="{E7E05BF1-38D5-4E57-B818-1AB9576200BB}" dt="2023-07-19T09:40:57.468" v="34"/>
        <pc:sldMkLst>
          <pc:docMk/>
          <pc:sldMk cId="1035658693" sldId="256"/>
        </pc:sldMkLst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2" creationId="{1939D736-7B23-B24B-A9CB-6AE0BA74F115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3" creationId="{C76165A1-06C8-2493-BF25-E36E8EB5C761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4" creationId="{C5CD048B-3C4C-594F-05CC-DFFE8F336922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5" creationId="{BFFF4E04-BEEC-4AAE-E06A-FCF057697575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6" creationId="{DB3C93A7-6B1F-A143-35AC-B4F66D7FE45B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8" creationId="{1158F320-94D5-F816-48EF-ED5646B2B921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29" creationId="{2F89600A-E345-7168-3725-D0CB5F679CA7}"/>
          </ac:spMkLst>
        </pc:spChg>
        <pc:spChg chg="del">
          <ac:chgData name="JUAN MANUEL LOZANO GIL" userId="618ed11e-cb2c-4b03-8ac9-a8cf52f924c9" providerId="ADAL" clId="{E7E05BF1-38D5-4E57-B818-1AB9576200BB}" dt="2023-07-19T09:37:59.190" v="1" actId="478"/>
          <ac:spMkLst>
            <pc:docMk/>
            <pc:sldMk cId="1035658693" sldId="256"/>
            <ac:spMk id="30" creationId="{CF2E5718-F873-7701-79BA-DC346D30C4D7}"/>
          </ac:spMkLst>
        </pc:spChg>
        <pc:spChg chg="del">
          <ac:chgData name="JUAN MANUEL LOZANO GIL" userId="618ed11e-cb2c-4b03-8ac9-a8cf52f924c9" providerId="ADAL" clId="{E7E05BF1-38D5-4E57-B818-1AB9576200BB}" dt="2023-07-19T09:37:59.190" v="1" actId="478"/>
          <ac:spMkLst>
            <pc:docMk/>
            <pc:sldMk cId="1035658693" sldId="256"/>
            <ac:spMk id="31" creationId="{280CD9EE-D429-E89B-439C-C3EA9C3A4900}"/>
          </ac:spMkLst>
        </pc:spChg>
        <pc:spChg chg="del">
          <ac:chgData name="JUAN MANUEL LOZANO GIL" userId="618ed11e-cb2c-4b03-8ac9-a8cf52f924c9" providerId="ADAL" clId="{E7E05BF1-38D5-4E57-B818-1AB9576200BB}" dt="2023-07-19T09:37:59.190" v="1" actId="478"/>
          <ac:spMkLst>
            <pc:docMk/>
            <pc:sldMk cId="1035658693" sldId="256"/>
            <ac:spMk id="32" creationId="{6DFC5A4D-0299-F727-DCE5-22A21CBD1E63}"/>
          </ac:spMkLst>
        </pc:spChg>
        <pc:spChg chg="del">
          <ac:chgData name="JUAN MANUEL LOZANO GIL" userId="618ed11e-cb2c-4b03-8ac9-a8cf52f924c9" providerId="ADAL" clId="{E7E05BF1-38D5-4E57-B818-1AB9576200BB}" dt="2023-07-19T09:37:59.190" v="1" actId="478"/>
          <ac:spMkLst>
            <pc:docMk/>
            <pc:sldMk cId="1035658693" sldId="256"/>
            <ac:spMk id="33" creationId="{E4EFA5E8-3477-2F24-9110-7460580DF651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35" creationId="{C162F2C1-B9C8-6F10-D2E8-CE81B00194F2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36" creationId="{1CF5EBE3-4112-F9EE-B45C-238C3EE0511E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39" creationId="{448DBE52-4A4C-CEE5-AF91-6A25CF6641BC}"/>
          </ac:spMkLst>
        </pc:spChg>
        <pc:spChg chg="add mod">
          <ac:chgData name="JUAN MANUEL LOZANO GIL" userId="618ed11e-cb2c-4b03-8ac9-a8cf52f924c9" providerId="ADAL" clId="{E7E05BF1-38D5-4E57-B818-1AB9576200BB}" dt="2023-07-19T09:40:57.468" v="34"/>
          <ac:spMkLst>
            <pc:docMk/>
            <pc:sldMk cId="1035658693" sldId="256"/>
            <ac:spMk id="40" creationId="{7888E4D4-A300-5AC7-34DB-F46F2EF57919}"/>
          </ac:spMkLst>
        </pc:spChg>
        <pc:grpChg chg="del">
          <ac:chgData name="JUAN MANUEL LOZANO GIL" userId="618ed11e-cb2c-4b03-8ac9-a8cf52f924c9" providerId="ADAL" clId="{E7E05BF1-38D5-4E57-B818-1AB9576200BB}" dt="2023-07-19T09:37:59.190" v="1" actId="478"/>
          <ac:grpSpMkLst>
            <pc:docMk/>
            <pc:sldMk cId="1035658693" sldId="256"/>
            <ac:grpSpMk id="28" creationId="{FDB1CC8B-16EF-CD3C-70E4-D811D6D67D15}"/>
          </ac:grpSpMkLst>
        </pc:grpChg>
        <pc:picChg chg="del">
          <ac:chgData name="JUAN MANUEL LOZANO GIL" userId="618ed11e-cb2c-4b03-8ac9-a8cf52f924c9" providerId="ADAL" clId="{E7E05BF1-38D5-4E57-B818-1AB9576200BB}" dt="2023-07-19T09:37:59.190" v="1" actId="478"/>
          <ac:picMkLst>
            <pc:docMk/>
            <pc:sldMk cId="1035658693" sldId="256"/>
            <ac:picMk id="7" creationId="{69940750-B75B-B98F-BF39-EBC60BB5F165}"/>
          </ac:picMkLst>
        </pc:picChg>
        <pc:picChg chg="add mod">
          <ac:chgData name="JUAN MANUEL LOZANO GIL" userId="618ed11e-cb2c-4b03-8ac9-a8cf52f924c9" providerId="ADAL" clId="{E7E05BF1-38D5-4E57-B818-1AB9576200BB}" dt="2023-07-19T09:40:57.468" v="34"/>
          <ac:picMkLst>
            <pc:docMk/>
            <pc:sldMk cId="1035658693" sldId="256"/>
            <ac:picMk id="37" creationId="{9DF0B5F6-565D-DAD4-D365-C002A3626550}"/>
          </ac:picMkLst>
        </pc:picChg>
        <pc:picChg chg="add mod">
          <ac:chgData name="JUAN MANUEL LOZANO GIL" userId="618ed11e-cb2c-4b03-8ac9-a8cf52f924c9" providerId="ADAL" clId="{E7E05BF1-38D5-4E57-B818-1AB9576200BB}" dt="2023-07-19T09:40:57.468" v="34"/>
          <ac:picMkLst>
            <pc:docMk/>
            <pc:sldMk cId="1035658693" sldId="256"/>
            <ac:picMk id="38" creationId="{93334AFA-5189-EC8C-805D-EA5ED03F966F}"/>
          </ac:picMkLst>
        </pc:picChg>
        <pc:cxnChg chg="del">
          <ac:chgData name="JUAN MANUEL LOZANO GIL" userId="618ed11e-cb2c-4b03-8ac9-a8cf52f924c9" providerId="ADAL" clId="{E7E05BF1-38D5-4E57-B818-1AB9576200BB}" dt="2023-07-19T09:37:59.190" v="1" actId="478"/>
          <ac:cxnSpMkLst>
            <pc:docMk/>
            <pc:sldMk cId="1035658693" sldId="256"/>
            <ac:cxnSpMk id="34" creationId="{9326A1D1-4DEE-52B7-1903-15FA92D9C514}"/>
          </ac:cxnSpMkLst>
        </pc:cxnChg>
      </pc:sldChg>
      <pc:sldChg chg="addSp delSp modSp mod">
        <pc:chgData name="JUAN MANUEL LOZANO GIL" userId="618ed11e-cb2c-4b03-8ac9-a8cf52f924c9" providerId="ADAL" clId="{E7E05BF1-38D5-4E57-B818-1AB9576200BB}" dt="2023-07-19T09:41:00.286" v="35" actId="1076"/>
        <pc:sldMkLst>
          <pc:docMk/>
          <pc:sldMk cId="236126241" sldId="257"/>
        </pc:sldMkLst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2" creationId="{0831C752-B74D-DD76-DCF0-1E861543FC56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3" creationId="{3CDFC918-7AE1-C2AA-4300-99C5578EAF30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4" creationId="{D5B27DDA-5548-05C5-66AC-757DAA0C0984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5" creationId="{87C49FDA-52E6-E1DA-2C33-10750058E3C7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6" creationId="{296DDEC2-20F2-6B70-9DEC-937F1D7941BD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17" creationId="{34EB2C8B-EC04-2DBE-FACF-E80158B829A4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18" creationId="{237D89B5-F3D4-3D20-5541-AFCCB4CF9286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23" creationId="{73ECEC19-5292-AD15-995F-507FCA0182D1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25" creationId="{6AB2FBA6-19E3-9300-A18E-3C93CD56466A}"/>
          </ac:spMkLst>
        </pc:spChg>
        <pc:spChg chg="del">
          <ac:chgData name="JUAN MANUEL LOZANO GIL" userId="618ed11e-cb2c-4b03-8ac9-a8cf52f924c9" providerId="ADAL" clId="{E7E05BF1-38D5-4E57-B818-1AB9576200BB}" dt="2023-07-19T09:37:56.999" v="0" actId="478"/>
          <ac:spMkLst>
            <pc:docMk/>
            <pc:sldMk cId="236126241" sldId="257"/>
            <ac:spMk id="29" creationId="{2135E244-1F3B-7BF0-3F61-E9745CC66162}"/>
          </ac:spMkLst>
        </pc:spChg>
        <pc:spChg chg="del">
          <ac:chgData name="JUAN MANUEL LOZANO GIL" userId="618ed11e-cb2c-4b03-8ac9-a8cf52f924c9" providerId="ADAL" clId="{E7E05BF1-38D5-4E57-B818-1AB9576200BB}" dt="2023-07-19T09:37:56.999" v="0" actId="478"/>
          <ac:spMkLst>
            <pc:docMk/>
            <pc:sldMk cId="236126241" sldId="257"/>
            <ac:spMk id="30" creationId="{E74161A8-0EA0-0E29-6DB3-12E4B8BA11B5}"/>
          </ac:spMkLst>
        </pc:spChg>
        <pc:spChg chg="del">
          <ac:chgData name="JUAN MANUEL LOZANO GIL" userId="618ed11e-cb2c-4b03-8ac9-a8cf52f924c9" providerId="ADAL" clId="{E7E05BF1-38D5-4E57-B818-1AB9576200BB}" dt="2023-07-19T09:37:56.999" v="0" actId="478"/>
          <ac:spMkLst>
            <pc:docMk/>
            <pc:sldMk cId="236126241" sldId="257"/>
            <ac:spMk id="31" creationId="{84D3EA54-4A00-DE9C-7E19-0C088717B835}"/>
          </ac:spMkLst>
        </pc:spChg>
        <pc:spChg chg="del">
          <ac:chgData name="JUAN MANUEL LOZANO GIL" userId="618ed11e-cb2c-4b03-8ac9-a8cf52f924c9" providerId="ADAL" clId="{E7E05BF1-38D5-4E57-B818-1AB9576200BB}" dt="2023-07-19T09:37:56.999" v="0" actId="478"/>
          <ac:spMkLst>
            <pc:docMk/>
            <pc:sldMk cId="236126241" sldId="257"/>
            <ac:spMk id="32" creationId="{935DF1CE-9C86-BAEA-FCBC-116924EE940B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36" creationId="{85E60A6F-5B41-54B1-3D69-864E0DFC081C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37" creationId="{F974BC5D-743E-3E54-CAE0-CA1547C736D8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38" creationId="{A013ADB4-C966-7846-3EFC-11B6178E19EB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39" creationId="{2C02B537-9237-4438-C870-36D129F310E2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0" creationId="{1C4BC4A6-C40C-1FE4-6D81-4D36D92A5997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1" creationId="{92EB3AC3-41A6-2C5D-699F-F0471D7E0A25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2" creationId="{DF8B1217-1D65-9DB6-BEC0-F36D3626124A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3" creationId="{61185E22-0CFC-FBA4-485D-02C844505AB9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4" creationId="{DCA67F13-8C91-2942-D9F9-9B7AED3259C3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5" creationId="{80CB0E96-2351-D6FC-DA95-E11278605460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48" creationId="{8C7DDA61-85DF-C486-1884-005F9B010C0A}"/>
          </ac:spMkLst>
        </pc:spChg>
        <pc:spChg chg="add mod">
          <ac:chgData name="JUAN MANUEL LOZANO GIL" userId="618ed11e-cb2c-4b03-8ac9-a8cf52f924c9" providerId="ADAL" clId="{E7E05BF1-38D5-4E57-B818-1AB9576200BB}" dt="2023-07-19T09:41:00.286" v="35" actId="1076"/>
          <ac:spMkLst>
            <pc:docMk/>
            <pc:sldMk cId="236126241" sldId="257"/>
            <ac:spMk id="49" creationId="{17604D44-3EAD-254B-365E-1E46E50C392E}"/>
          </ac:spMkLst>
        </pc:spChg>
        <pc:spChg chg="add del mod">
          <ac:chgData name="JUAN MANUEL LOZANO GIL" userId="618ed11e-cb2c-4b03-8ac9-a8cf52f924c9" providerId="ADAL" clId="{E7E05BF1-38D5-4E57-B818-1AB9576200BB}" dt="2023-07-19T09:40:56.520" v="33" actId="21"/>
          <ac:spMkLst>
            <pc:docMk/>
            <pc:sldMk cId="236126241" sldId="257"/>
            <ac:spMk id="50" creationId="{7C6B68A9-9C88-3251-73B5-02C16B703439}"/>
          </ac:spMkLst>
        </pc:spChg>
        <pc:grpChg chg="del">
          <ac:chgData name="JUAN MANUEL LOZANO GIL" userId="618ed11e-cb2c-4b03-8ac9-a8cf52f924c9" providerId="ADAL" clId="{E7E05BF1-38D5-4E57-B818-1AB9576200BB}" dt="2023-07-19T09:37:56.999" v="0" actId="478"/>
          <ac:grpSpMkLst>
            <pc:docMk/>
            <pc:sldMk cId="236126241" sldId="257"/>
            <ac:grpSpMk id="8" creationId="{6ECEC6D2-B89B-EC32-D2E5-16233731C6B3}"/>
          </ac:grpSpMkLst>
        </pc:grpChg>
        <pc:picChg chg="del">
          <ac:chgData name="JUAN MANUEL LOZANO GIL" userId="618ed11e-cb2c-4b03-8ac9-a8cf52f924c9" providerId="ADAL" clId="{E7E05BF1-38D5-4E57-B818-1AB9576200BB}" dt="2023-07-19T09:37:56.999" v="0" actId="478"/>
          <ac:picMkLst>
            <pc:docMk/>
            <pc:sldMk cId="236126241" sldId="257"/>
            <ac:picMk id="7" creationId="{249F3737-2ECA-678D-A59E-494C5B48DC52}"/>
          </ac:picMkLst>
        </pc:picChg>
        <pc:picChg chg="add mod">
          <ac:chgData name="JUAN MANUEL LOZANO GIL" userId="618ed11e-cb2c-4b03-8ac9-a8cf52f924c9" providerId="ADAL" clId="{E7E05BF1-38D5-4E57-B818-1AB9576200BB}" dt="2023-07-19T09:41:00.286" v="35" actId="1076"/>
          <ac:picMkLst>
            <pc:docMk/>
            <pc:sldMk cId="236126241" sldId="257"/>
            <ac:picMk id="28" creationId="{244D572C-BDE0-FA5F-FFE6-CC89FE68798B}"/>
          </ac:picMkLst>
        </pc:picChg>
        <pc:picChg chg="add mod">
          <ac:chgData name="JUAN MANUEL LOZANO GIL" userId="618ed11e-cb2c-4b03-8ac9-a8cf52f924c9" providerId="ADAL" clId="{E7E05BF1-38D5-4E57-B818-1AB9576200BB}" dt="2023-07-19T09:41:00.286" v="35" actId="1076"/>
          <ac:picMkLst>
            <pc:docMk/>
            <pc:sldMk cId="236126241" sldId="257"/>
            <ac:picMk id="34" creationId="{2414A3BD-49B9-F6CC-8EDD-AA7913B25C41}"/>
          </ac:picMkLst>
        </pc:picChg>
        <pc:picChg chg="add del mod">
          <ac:chgData name="JUAN MANUEL LOZANO GIL" userId="618ed11e-cb2c-4b03-8ac9-a8cf52f924c9" providerId="ADAL" clId="{E7E05BF1-38D5-4E57-B818-1AB9576200BB}" dt="2023-07-19T09:40:56.520" v="33" actId="21"/>
          <ac:picMkLst>
            <pc:docMk/>
            <pc:sldMk cId="236126241" sldId="257"/>
            <ac:picMk id="46" creationId="{113CAFED-B7AE-BE91-3C4C-5A5D978A66DA}"/>
          </ac:picMkLst>
        </pc:picChg>
        <pc:picChg chg="add del mod">
          <ac:chgData name="JUAN MANUEL LOZANO GIL" userId="618ed11e-cb2c-4b03-8ac9-a8cf52f924c9" providerId="ADAL" clId="{E7E05BF1-38D5-4E57-B818-1AB9576200BB}" dt="2023-07-19T09:40:56.520" v="33" actId="21"/>
          <ac:picMkLst>
            <pc:docMk/>
            <pc:sldMk cId="236126241" sldId="257"/>
            <ac:picMk id="47" creationId="{83CC734D-B3E6-EC4A-577A-918E481F67BB}"/>
          </ac:picMkLst>
        </pc:picChg>
        <pc:cxnChg chg="del">
          <ac:chgData name="JUAN MANUEL LOZANO GIL" userId="618ed11e-cb2c-4b03-8ac9-a8cf52f924c9" providerId="ADAL" clId="{E7E05BF1-38D5-4E57-B818-1AB9576200BB}" dt="2023-07-19T09:37:56.999" v="0" actId="478"/>
          <ac:cxnSpMkLst>
            <pc:docMk/>
            <pc:sldMk cId="236126241" sldId="257"/>
            <ac:cxnSpMk id="33" creationId="{6AB4F24E-2418-3177-99FE-E328E98D14F3}"/>
          </ac:cxnSpMkLst>
        </pc:cxnChg>
      </pc:sldChg>
      <pc:sldChg chg="addSp delSp modSp new mod">
        <pc:chgData name="JUAN MANUEL LOZANO GIL" userId="618ed11e-cb2c-4b03-8ac9-a8cf52f924c9" providerId="ADAL" clId="{E7E05BF1-38D5-4E57-B818-1AB9576200BB}" dt="2023-07-19T10:01:14.163" v="44" actId="1076"/>
        <pc:sldMkLst>
          <pc:docMk/>
          <pc:sldMk cId="1875971361" sldId="258"/>
        </pc:sldMkLst>
        <pc:spChg chg="del">
          <ac:chgData name="JUAN MANUEL LOZANO GIL" userId="618ed11e-cb2c-4b03-8ac9-a8cf52f924c9" providerId="ADAL" clId="{E7E05BF1-38D5-4E57-B818-1AB9576200BB}" dt="2023-07-19T10:00:57.330" v="37" actId="478"/>
          <ac:spMkLst>
            <pc:docMk/>
            <pc:sldMk cId="1875971361" sldId="258"/>
            <ac:spMk id="2" creationId="{6684E8C3-A557-0F12-ABD0-893A46121528}"/>
          </ac:spMkLst>
        </pc:spChg>
        <pc:spChg chg="del">
          <ac:chgData name="JUAN MANUEL LOZANO GIL" userId="618ed11e-cb2c-4b03-8ac9-a8cf52f924c9" providerId="ADAL" clId="{E7E05BF1-38D5-4E57-B818-1AB9576200BB}" dt="2023-07-19T10:00:57.330" v="37" actId="478"/>
          <ac:spMkLst>
            <pc:docMk/>
            <pc:sldMk cId="1875971361" sldId="258"/>
            <ac:spMk id="3" creationId="{ADF86E33-FC5D-1D30-049F-F3B666883173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5" creationId="{44D96089-E5E9-2070-98CD-F2070FD04780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6" creationId="{8F33BC85-AB8D-A5A0-0BF5-8635F9AD05D2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7" creationId="{86C6DEAF-E8AB-2697-0968-554A344227DE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8" creationId="{F788AC76-D4AE-E7E4-EF62-B606AAF416C5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9" creationId="{75928509-4772-C50A-CF6C-5252A8EAECED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10" creationId="{338D0A1A-A50A-445E-E693-F2367EEFC235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11" creationId="{F0A09AEF-50B4-B820-CD11-37E554C2625F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12" creationId="{8F086145-EC6B-28BC-4D25-0778FCB9EEF0}"/>
          </ac:spMkLst>
        </pc:spChg>
        <pc:spChg chg="mod">
          <ac:chgData name="JUAN MANUEL LOZANO GIL" userId="618ed11e-cb2c-4b03-8ac9-a8cf52f924c9" providerId="ADAL" clId="{E7E05BF1-38D5-4E57-B818-1AB9576200BB}" dt="2023-07-19T10:00:58.138" v="38"/>
          <ac:spMkLst>
            <pc:docMk/>
            <pc:sldMk cId="1875971361" sldId="258"/>
            <ac:spMk id="13" creationId="{6152A7AB-CF98-600D-4F02-391B0ACA5A98}"/>
          </ac:spMkLst>
        </pc:spChg>
        <pc:spChg chg="del mod">
          <ac:chgData name="JUAN MANUEL LOZANO GIL" userId="618ed11e-cb2c-4b03-8ac9-a8cf52f924c9" providerId="ADAL" clId="{E7E05BF1-38D5-4E57-B818-1AB9576200BB}" dt="2023-07-19T10:01:00.858" v="40" actId="478"/>
          <ac:spMkLst>
            <pc:docMk/>
            <pc:sldMk cId="1875971361" sldId="258"/>
            <ac:spMk id="14" creationId="{11215658-8FE4-A98E-F992-2D57796A5343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18" creationId="{C5A54325-11C1-AB57-1F18-025B343AA7A6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19" creationId="{16A4D12A-E64F-656F-D22D-25BA30C46DC3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20" creationId="{BD90131F-67EC-B539-6475-62B32E3799C4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21" creationId="{A3051FF7-1377-D4D2-11B0-A72B552C2782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22" creationId="{4ACFA866-BF45-C0B1-6BB6-AA7AFCDF4A3A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23" creationId="{0D73D90C-9F10-68D8-CB04-E8377277C286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24" creationId="{713B7955-3A99-5982-C1CF-71281D3B21D4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25" creationId="{9DA35D7C-5FF6-36D2-1600-0012C85790FE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26" creationId="{7ECA7BC1-EF5E-8C50-56EF-D3927DE9AFB2}"/>
          </ac:spMkLst>
        </pc:spChg>
        <pc:spChg chg="mod">
          <ac:chgData name="JUAN MANUEL LOZANO GIL" userId="618ed11e-cb2c-4b03-8ac9-a8cf52f924c9" providerId="ADAL" clId="{E7E05BF1-38D5-4E57-B818-1AB9576200BB}" dt="2023-07-19T10:01:04.681" v="41"/>
          <ac:spMkLst>
            <pc:docMk/>
            <pc:sldMk cId="1875971361" sldId="258"/>
            <ac:spMk id="27" creationId="{DD069E1A-82E3-93A3-A628-E90A01013612}"/>
          </ac:spMkLst>
        </pc:spChg>
        <pc:spChg chg="add mod">
          <ac:chgData name="JUAN MANUEL LOZANO GIL" userId="618ed11e-cb2c-4b03-8ac9-a8cf52f924c9" providerId="ADAL" clId="{E7E05BF1-38D5-4E57-B818-1AB9576200BB}" dt="2023-07-19T10:01:14.163" v="44" actId="1076"/>
          <ac:spMkLst>
            <pc:docMk/>
            <pc:sldMk cId="1875971361" sldId="258"/>
            <ac:spMk id="30" creationId="{DE39B055-CB52-BF3C-D95A-5D0CC42CD599}"/>
          </ac:spMkLst>
        </pc:spChg>
        <pc:grpChg chg="add mod">
          <ac:chgData name="JUAN MANUEL LOZANO GIL" userId="618ed11e-cb2c-4b03-8ac9-a8cf52f924c9" providerId="ADAL" clId="{E7E05BF1-38D5-4E57-B818-1AB9576200BB}" dt="2023-07-19T10:00:59.451" v="39" actId="1076"/>
          <ac:grpSpMkLst>
            <pc:docMk/>
            <pc:sldMk cId="1875971361" sldId="258"/>
            <ac:grpSpMk id="4" creationId="{C9BD765E-66C1-174E-B032-3485D0B8678A}"/>
          </ac:grpSpMkLst>
        </pc:grpChg>
        <pc:grpChg chg="add del mod">
          <ac:chgData name="JUAN MANUEL LOZANO GIL" userId="618ed11e-cb2c-4b03-8ac9-a8cf52f924c9" providerId="ADAL" clId="{E7E05BF1-38D5-4E57-B818-1AB9576200BB}" dt="2023-07-19T10:01:06.132" v="42" actId="478"/>
          <ac:grpSpMkLst>
            <pc:docMk/>
            <pc:sldMk cId="1875971361" sldId="258"/>
            <ac:grpSpMk id="17" creationId="{CF39ACA7-7A3F-0211-5DAB-803DFD3302FE}"/>
          </ac:grpSpMkLst>
        </pc:grpChg>
        <pc:picChg chg="mod">
          <ac:chgData name="JUAN MANUEL LOZANO GIL" userId="618ed11e-cb2c-4b03-8ac9-a8cf52f924c9" providerId="ADAL" clId="{E7E05BF1-38D5-4E57-B818-1AB9576200BB}" dt="2023-07-19T10:00:58.138" v="38"/>
          <ac:picMkLst>
            <pc:docMk/>
            <pc:sldMk cId="1875971361" sldId="258"/>
            <ac:picMk id="15" creationId="{AC8A3110-F31F-42A9-D950-E93C73AE727A}"/>
          </ac:picMkLst>
        </pc:picChg>
        <pc:picChg chg="mod">
          <ac:chgData name="JUAN MANUEL LOZANO GIL" userId="618ed11e-cb2c-4b03-8ac9-a8cf52f924c9" providerId="ADAL" clId="{E7E05BF1-38D5-4E57-B818-1AB9576200BB}" dt="2023-07-19T10:00:58.138" v="38"/>
          <ac:picMkLst>
            <pc:docMk/>
            <pc:sldMk cId="1875971361" sldId="258"/>
            <ac:picMk id="16" creationId="{D5998CB8-3D7F-A2E2-EF13-7AC62335CD9E}"/>
          </ac:picMkLst>
        </pc:picChg>
        <pc:picChg chg="mod">
          <ac:chgData name="JUAN MANUEL LOZANO GIL" userId="618ed11e-cb2c-4b03-8ac9-a8cf52f924c9" providerId="ADAL" clId="{E7E05BF1-38D5-4E57-B818-1AB9576200BB}" dt="2023-07-19T10:01:04.681" v="41"/>
          <ac:picMkLst>
            <pc:docMk/>
            <pc:sldMk cId="1875971361" sldId="258"/>
            <ac:picMk id="28" creationId="{6F0D79A8-5CFA-8AD4-1A28-66BF8EA42AAE}"/>
          </ac:picMkLst>
        </pc:picChg>
        <pc:picChg chg="mod">
          <ac:chgData name="JUAN MANUEL LOZANO GIL" userId="618ed11e-cb2c-4b03-8ac9-a8cf52f924c9" providerId="ADAL" clId="{E7E05BF1-38D5-4E57-B818-1AB9576200BB}" dt="2023-07-19T10:01:04.681" v="41"/>
          <ac:picMkLst>
            <pc:docMk/>
            <pc:sldMk cId="1875971361" sldId="258"/>
            <ac:picMk id="29" creationId="{CFDCF007-01C7-344F-FFCC-16507222F25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8CA4392-5E73-0108-CBBA-28691F1D59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0D831818-D66A-18DB-2017-A935F42A5C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945DBFD-F2FF-7765-D9DC-4D13E0376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ACB39D-BD0B-B377-D862-7F76BD894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01EEF2C-F670-3E35-874B-7A6553439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5879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399512B-993D-96DA-AC3E-AAB7861E0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BD6B8C9-1712-ED3E-73BA-1670E9A317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6A1C69F-B153-4BDA-6A9F-D6B8C78A0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7B9D6BE-1C66-A9CD-183A-8FFB74192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0348AB4-4AB1-23FD-AE9F-A4C54A7EC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6540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F1C2DFD-FDDB-EDA9-D82E-DFE1DCCED7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E70710D-9E2C-B5B9-4701-DFBF9615A4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DB6BC3F-4028-BC1A-E8ED-D0E7BA723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B975C6B-EB7F-F388-2D1E-22B65A833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A3504A6-B28E-9494-9EE8-4124106C2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423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6983DC9-75BD-8969-675D-03917E38D7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01FAE08-B4BE-7188-9EF3-931CC5F9AE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656958-63CE-07EA-BD1D-DCC8256E8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E7EC13-1DAD-28E2-B8E6-85BF6C755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791C74-5785-8DBF-4BFE-4D689906C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8846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C954263-6C6D-09E0-104C-260D25D3D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9463E93-22D9-ED0C-168D-87EAE31EB7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4D53D07-A027-EFAF-135F-11DE7E2E1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21B540-D5BD-5142-05A3-4753F291F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768CAEA-DB12-BCA1-3FEB-8BAD219D0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9115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FD5BF1-DD48-BCFC-C990-E5DE502A74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AB54EEE-3B55-ABE1-DC2C-B1B8DD3201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0B7CFFD-CAFC-B168-7BFA-F9531324AA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6955CEB-8849-E355-8109-ACD2A4B25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55B132F-0F3A-8991-19AB-36271FC56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66419C9-7C32-2130-E201-373A83BAD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0657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E980DEA-689F-B910-8678-673A468EB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C7F72B2-F1D6-955C-8F76-C75A09C74D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F25F160-D135-6B71-4151-5D85821BE1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C90321E-F145-4921-C287-FE635C7E86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311CBB5-9DA1-530E-680D-D68DF21D67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AE2CCF7-0C74-9CCD-CD7D-CE9E29E0F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DE92749C-EC66-5F54-69FD-19A18A2BB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AC9F7C4-C008-5AB0-03D1-301F3CD14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1415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A4F8CB4-AACB-DCBE-07E9-FBA9A2A94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54F15A6-4026-154B-C252-0FF94CA07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D216B02-FBEB-D41A-28DA-750E2B6AD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7ABF464-DCBD-ACE2-D66B-B447DE8FC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6795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FBC671B-7586-C677-B853-2C705E63A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01ED5C2-142F-82C4-7FF5-41F16DAAB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23E5E6F4-AF49-C23E-14C2-699C56515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8037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259816-12EA-74F9-6BA5-4FD35CB44E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5C1C8ED-6485-4D35-69D6-17E578A2A3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128AE38-51BA-F1D6-B2F5-1F38A24517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C29B3D1-B531-81EF-AE34-BC61D910D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715909C-B024-CDA0-C746-E68FAEDEA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F7E54C9-A667-1011-0551-28B57432F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4238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ABADBE-91EB-E67C-44C0-062D0A7F5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FAD65BE-9342-E1B6-7EEC-8F5C310724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D29A3AF-E859-18E6-6E6B-B611064D49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7628F86-C761-29AA-ED8E-1974A9176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35DA35A-2D9C-32BF-AC0B-A29D49B04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3D0A14D-A3A9-2456-DCDF-CC7BA7FBB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2002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FDD870D1-4E17-32B3-0525-D3D052031F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3431573-D3DA-3DD4-6756-5B6ACD9893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5D1E7DB-2951-B127-367A-97FEDC0FAD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8485C-36A0-4164-A4C8-28F5001E2DB2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E9843E6-E161-EE41-6982-F48050A3DF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F3A41A4-FBD4-91E9-9BB0-F4579A0FCC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6746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4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0831C752-B74D-DD76-DCF0-1E861543FC56}"/>
              </a:ext>
            </a:extLst>
          </p:cNvPr>
          <p:cNvSpPr txBox="1"/>
          <p:nvPr/>
        </p:nvSpPr>
        <p:spPr>
          <a:xfrm rot="16200000">
            <a:off x="3992633" y="190644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/>
              <a:t>INPUT</a:t>
            </a:r>
            <a:endParaRPr lang="es-ES_tradnl" dirty="0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3CDFC918-7AE1-C2AA-4300-99C5578EAF30}"/>
              </a:ext>
            </a:extLst>
          </p:cNvPr>
          <p:cNvSpPr txBox="1"/>
          <p:nvPr/>
        </p:nvSpPr>
        <p:spPr>
          <a:xfrm rot="16200000">
            <a:off x="4448788" y="1928082"/>
            <a:ext cx="7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</a:t>
            </a:r>
            <a:r>
              <a:rPr lang="es-ES_tradnl" dirty="0" err="1"/>
              <a:t>IgG</a:t>
            </a:r>
            <a:endParaRPr lang="es-ES_tradnl" dirty="0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D5B27DDA-5548-05C5-66AC-757DAA0C0984}"/>
              </a:ext>
            </a:extLst>
          </p:cNvPr>
          <p:cNvSpPr txBox="1"/>
          <p:nvPr/>
        </p:nvSpPr>
        <p:spPr>
          <a:xfrm rot="16200000">
            <a:off x="4785951" y="1764720"/>
            <a:ext cx="1021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NLRP1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87C49FDA-52E6-E1DA-2C33-10750058E3C7}"/>
              </a:ext>
            </a:extLst>
          </p:cNvPr>
          <p:cNvSpPr txBox="1"/>
          <p:nvPr/>
        </p:nvSpPr>
        <p:spPr>
          <a:xfrm>
            <a:off x="3005937" y="2826249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82kDa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296DDEC2-20F2-6B70-9DEC-937F1D7941BD}"/>
              </a:ext>
            </a:extLst>
          </p:cNvPr>
          <p:cNvSpPr txBox="1"/>
          <p:nvPr/>
        </p:nvSpPr>
        <p:spPr>
          <a:xfrm>
            <a:off x="2988813" y="3233875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16kDa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34EB2C8B-EC04-2DBE-FACF-E80158B829A4}"/>
              </a:ext>
            </a:extLst>
          </p:cNvPr>
          <p:cNvSpPr txBox="1"/>
          <p:nvPr/>
        </p:nvSpPr>
        <p:spPr>
          <a:xfrm>
            <a:off x="3023278" y="3636552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82kDa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237D89B5-F3D4-3D20-5541-AFCCB4CF9286}"/>
              </a:ext>
            </a:extLst>
          </p:cNvPr>
          <p:cNvSpPr txBox="1"/>
          <p:nvPr/>
        </p:nvSpPr>
        <p:spPr>
          <a:xfrm>
            <a:off x="3005937" y="3951183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64kDa</a:t>
            </a:r>
            <a:endParaRPr lang="es-ES_tradnl" sz="1050" dirty="0"/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73ECEC19-5292-AD15-995F-507FCA0182D1}"/>
              </a:ext>
            </a:extLst>
          </p:cNvPr>
          <p:cNvSpPr txBox="1"/>
          <p:nvPr/>
        </p:nvSpPr>
        <p:spPr>
          <a:xfrm>
            <a:off x="3005937" y="4290726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49kDa</a:t>
            </a:r>
            <a:endParaRPr lang="es-ES_tradnl" sz="1050" dirty="0"/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6AB2FBA6-19E3-9300-A18E-3C93CD56466A}"/>
              </a:ext>
            </a:extLst>
          </p:cNvPr>
          <p:cNvSpPr txBox="1"/>
          <p:nvPr/>
        </p:nvSpPr>
        <p:spPr>
          <a:xfrm>
            <a:off x="3005937" y="4649875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37kDa</a:t>
            </a:r>
            <a:endParaRPr lang="es-ES_tradnl" sz="1050" dirty="0"/>
          </a:p>
        </p:txBody>
      </p:sp>
      <p:pic>
        <p:nvPicPr>
          <p:cNvPr id="28" name="Imagen 27">
            <a:extLst>
              <a:ext uri="{FF2B5EF4-FFF2-40B4-BE49-F238E27FC236}">
                <a16:creationId xmlns:a16="http://schemas.microsoft.com/office/drawing/2014/main" id="{244D572C-BDE0-FA5F-FFE6-CC89FE6879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" contrast="-2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417" t="34107" r="55324" b="14786"/>
          <a:stretch/>
        </p:blipFill>
        <p:spPr>
          <a:xfrm>
            <a:off x="3504367" y="2433358"/>
            <a:ext cx="400725" cy="2914220"/>
          </a:xfrm>
          <a:prstGeom prst="rect">
            <a:avLst/>
          </a:prstGeom>
        </p:spPr>
      </p:pic>
      <p:pic>
        <p:nvPicPr>
          <p:cNvPr id="34" name="Imagen 33">
            <a:extLst>
              <a:ext uri="{FF2B5EF4-FFF2-40B4-BE49-F238E27FC236}">
                <a16:creationId xmlns:a16="http://schemas.microsoft.com/office/drawing/2014/main" id="{2414A3BD-49B9-F6CC-8EDD-AA7913B25C4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28" t="36882" r="33188" b="14967"/>
          <a:stretch/>
        </p:blipFill>
        <p:spPr>
          <a:xfrm>
            <a:off x="3898007" y="2605673"/>
            <a:ext cx="1917581" cy="26550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CuadroTexto 35">
            <a:extLst>
              <a:ext uri="{FF2B5EF4-FFF2-40B4-BE49-F238E27FC236}">
                <a16:creationId xmlns:a16="http://schemas.microsoft.com/office/drawing/2014/main" id="{85E60A6F-5B41-54B1-3D69-864E0DFC081C}"/>
              </a:ext>
            </a:extLst>
          </p:cNvPr>
          <p:cNvSpPr txBox="1"/>
          <p:nvPr/>
        </p:nvSpPr>
        <p:spPr>
          <a:xfrm>
            <a:off x="5492529" y="3581851"/>
            <a:ext cx="1631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_tradnl" dirty="0"/>
              <a:t>LRRFIP1</a:t>
            </a:r>
          </a:p>
        </p:txBody>
      </p:sp>
      <p:sp>
        <p:nvSpPr>
          <p:cNvPr id="49" name="Rectángulo 48">
            <a:extLst>
              <a:ext uri="{FF2B5EF4-FFF2-40B4-BE49-F238E27FC236}">
                <a16:creationId xmlns:a16="http://schemas.microsoft.com/office/drawing/2014/main" id="{17604D44-3EAD-254B-365E-1E46E50C392E}"/>
              </a:ext>
            </a:extLst>
          </p:cNvPr>
          <p:cNvSpPr/>
          <p:nvPr/>
        </p:nvSpPr>
        <p:spPr>
          <a:xfrm>
            <a:off x="4054468" y="2881159"/>
            <a:ext cx="1550593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126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1939D736-7B23-B24B-A9CB-6AE0BA74F115}"/>
              </a:ext>
            </a:extLst>
          </p:cNvPr>
          <p:cNvSpPr txBox="1"/>
          <p:nvPr/>
        </p:nvSpPr>
        <p:spPr>
          <a:xfrm rot="16200000">
            <a:off x="4800118" y="2007277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NPUT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C76165A1-06C8-2493-BF25-E36E8EB5C761}"/>
              </a:ext>
            </a:extLst>
          </p:cNvPr>
          <p:cNvSpPr txBox="1"/>
          <p:nvPr/>
        </p:nvSpPr>
        <p:spPr>
          <a:xfrm rot="16200000">
            <a:off x="5526545" y="1821154"/>
            <a:ext cx="1021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NLRP1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C5CD048B-3C4C-594F-05CC-DFFE8F336922}"/>
              </a:ext>
            </a:extLst>
          </p:cNvPr>
          <p:cNvSpPr txBox="1"/>
          <p:nvPr/>
        </p:nvSpPr>
        <p:spPr>
          <a:xfrm rot="16200000">
            <a:off x="5235066" y="2007277"/>
            <a:ext cx="7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</a:t>
            </a:r>
            <a:r>
              <a:rPr lang="es-ES_tradnl" dirty="0" err="1"/>
              <a:t>IgG</a:t>
            </a:r>
            <a:endParaRPr lang="es-ES_tradnl" dirty="0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BFFF4E04-BEEC-4AAE-E06A-FCF057697575}"/>
              </a:ext>
            </a:extLst>
          </p:cNvPr>
          <p:cNvSpPr txBox="1"/>
          <p:nvPr/>
        </p:nvSpPr>
        <p:spPr>
          <a:xfrm>
            <a:off x="3864303" y="2972330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82kDa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DB3C93A7-6B1F-A143-35AC-B4F66D7FE45B}"/>
              </a:ext>
            </a:extLst>
          </p:cNvPr>
          <p:cNvSpPr txBox="1"/>
          <p:nvPr/>
        </p:nvSpPr>
        <p:spPr>
          <a:xfrm>
            <a:off x="3847179" y="3379956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16kDa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158F320-94D5-F816-48EF-ED5646B2B921}"/>
              </a:ext>
            </a:extLst>
          </p:cNvPr>
          <p:cNvSpPr txBox="1"/>
          <p:nvPr/>
        </p:nvSpPr>
        <p:spPr>
          <a:xfrm>
            <a:off x="3881643" y="3741766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82kDa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F89600A-E345-7168-3725-D0CB5F679CA7}"/>
              </a:ext>
            </a:extLst>
          </p:cNvPr>
          <p:cNvSpPr txBox="1"/>
          <p:nvPr/>
        </p:nvSpPr>
        <p:spPr>
          <a:xfrm>
            <a:off x="3864303" y="4135742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64kDa</a:t>
            </a:r>
            <a:endParaRPr lang="es-ES_tradnl" sz="1050" dirty="0"/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C162F2C1-B9C8-6F10-D2E8-CE81B00194F2}"/>
              </a:ext>
            </a:extLst>
          </p:cNvPr>
          <p:cNvSpPr txBox="1"/>
          <p:nvPr/>
        </p:nvSpPr>
        <p:spPr>
          <a:xfrm>
            <a:off x="3864303" y="4434288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49kDa</a:t>
            </a:r>
            <a:endParaRPr lang="es-ES_tradnl" sz="1050" dirty="0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1CF5EBE3-4112-F9EE-B45C-238C3EE0511E}"/>
              </a:ext>
            </a:extLst>
          </p:cNvPr>
          <p:cNvSpPr txBox="1"/>
          <p:nvPr/>
        </p:nvSpPr>
        <p:spPr>
          <a:xfrm>
            <a:off x="3875106" y="4771792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37kDa</a:t>
            </a:r>
            <a:endParaRPr lang="es-ES_tradnl" sz="1050" dirty="0"/>
          </a:p>
        </p:txBody>
      </p:sp>
      <p:pic>
        <p:nvPicPr>
          <p:cNvPr id="37" name="Imagen 36">
            <a:extLst>
              <a:ext uri="{FF2B5EF4-FFF2-40B4-BE49-F238E27FC236}">
                <a16:creationId xmlns:a16="http://schemas.microsoft.com/office/drawing/2014/main" id="{9DF0B5F6-565D-DAD4-D365-C002A36265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33" t="27028" r="60547" b="21081"/>
          <a:stretch/>
        </p:blipFill>
        <p:spPr>
          <a:xfrm>
            <a:off x="4464762" y="2549016"/>
            <a:ext cx="443496" cy="2958983"/>
          </a:xfrm>
          <a:prstGeom prst="rect">
            <a:avLst/>
          </a:prstGeom>
        </p:spPr>
      </p:pic>
      <p:pic>
        <p:nvPicPr>
          <p:cNvPr id="38" name="Imagen 37">
            <a:extLst>
              <a:ext uri="{FF2B5EF4-FFF2-40B4-BE49-F238E27FC236}">
                <a16:creationId xmlns:a16="http://schemas.microsoft.com/office/drawing/2014/main" id="{93334AFA-5189-EC8C-805D-EA5ED03F966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63" t="27028" r="39059" b="21081"/>
          <a:stretch/>
        </p:blipFill>
        <p:spPr>
          <a:xfrm>
            <a:off x="4909014" y="2549016"/>
            <a:ext cx="1636632" cy="29589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CuadroTexto 38">
            <a:extLst>
              <a:ext uri="{FF2B5EF4-FFF2-40B4-BE49-F238E27FC236}">
                <a16:creationId xmlns:a16="http://schemas.microsoft.com/office/drawing/2014/main" id="{448DBE52-4A4C-CEE5-AF91-6A25CF6641BC}"/>
              </a:ext>
            </a:extLst>
          </p:cNvPr>
          <p:cNvSpPr txBox="1"/>
          <p:nvPr/>
        </p:nvSpPr>
        <p:spPr>
          <a:xfrm>
            <a:off x="6163475" y="3648212"/>
            <a:ext cx="1631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_tradnl" dirty="0"/>
              <a:t>NLRP1</a:t>
            </a:r>
          </a:p>
        </p:txBody>
      </p:sp>
      <p:sp>
        <p:nvSpPr>
          <p:cNvPr id="40" name="Rectángulo 39">
            <a:extLst>
              <a:ext uri="{FF2B5EF4-FFF2-40B4-BE49-F238E27FC236}">
                <a16:creationId xmlns:a16="http://schemas.microsoft.com/office/drawing/2014/main" id="{7888E4D4-A300-5AC7-34DB-F46F2EF57919}"/>
              </a:ext>
            </a:extLst>
          </p:cNvPr>
          <p:cNvSpPr/>
          <p:nvPr/>
        </p:nvSpPr>
        <p:spPr>
          <a:xfrm>
            <a:off x="4880814" y="3090832"/>
            <a:ext cx="1550593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035658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>
            <a:extLst>
              <a:ext uri="{FF2B5EF4-FFF2-40B4-BE49-F238E27FC236}">
                <a16:creationId xmlns:a16="http://schemas.microsoft.com/office/drawing/2014/main" id="{C9BD765E-66C1-174E-B032-3485D0B8678A}"/>
              </a:ext>
            </a:extLst>
          </p:cNvPr>
          <p:cNvGrpSpPr/>
          <p:nvPr/>
        </p:nvGrpSpPr>
        <p:grpSpPr>
          <a:xfrm>
            <a:off x="3737049" y="1004844"/>
            <a:ext cx="2325809" cy="3880370"/>
            <a:chOff x="1026357" y="1132049"/>
            <a:chExt cx="2325809" cy="3880370"/>
          </a:xfrm>
        </p:grpSpPr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44D96089-E5E9-2070-98CD-F2070FD04780}"/>
                </a:ext>
              </a:extLst>
            </p:cNvPr>
            <p:cNvSpPr txBox="1"/>
            <p:nvPr/>
          </p:nvSpPr>
          <p:spPr>
            <a:xfrm rot="16200000">
              <a:off x="2595869" y="1519014"/>
              <a:ext cx="1143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dirty="0"/>
                <a:t>IP hNLRP1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8F33BC85-AB8D-A5A0-0BF5-8635F9AD05D2}"/>
                </a:ext>
              </a:extLst>
            </p:cNvPr>
            <p:cNvSpPr txBox="1"/>
            <p:nvPr/>
          </p:nvSpPr>
          <p:spPr>
            <a:xfrm rot="16200000">
              <a:off x="1948244" y="1705137"/>
              <a:ext cx="7697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dirty="0"/>
                <a:t>INPUT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86C6DEAF-E8AB-2697-0968-554A344227DE}"/>
                </a:ext>
              </a:extLst>
            </p:cNvPr>
            <p:cNvSpPr txBox="1"/>
            <p:nvPr/>
          </p:nvSpPr>
          <p:spPr>
            <a:xfrm rot="16200000">
              <a:off x="2337128" y="1726778"/>
              <a:ext cx="7264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dirty="0"/>
                <a:t>IP </a:t>
              </a:r>
              <a:r>
                <a:rPr lang="es-ES_tradnl" dirty="0" err="1"/>
                <a:t>IgG</a:t>
              </a:r>
              <a:endParaRPr lang="es-ES_tradnl" dirty="0"/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F788AC76-D4AE-E7E4-EF62-B606AAF416C5}"/>
                </a:ext>
              </a:extLst>
            </p:cNvPr>
            <p:cNvSpPr txBox="1"/>
            <p:nvPr/>
          </p:nvSpPr>
          <p:spPr>
            <a:xfrm>
              <a:off x="1026357" y="2506611"/>
              <a:ext cx="5998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182kDa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75928509-4772-C50A-CF6C-5252A8EAECED}"/>
                </a:ext>
              </a:extLst>
            </p:cNvPr>
            <p:cNvSpPr txBox="1"/>
            <p:nvPr/>
          </p:nvSpPr>
          <p:spPr>
            <a:xfrm>
              <a:off x="1031156" y="2837408"/>
              <a:ext cx="5998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116kDa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338D0A1A-A50A-445E-E693-F2367EEFC235}"/>
                </a:ext>
              </a:extLst>
            </p:cNvPr>
            <p:cNvSpPr txBox="1"/>
            <p:nvPr/>
          </p:nvSpPr>
          <p:spPr>
            <a:xfrm>
              <a:off x="1092049" y="3155226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82kDa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F0A09AEF-50B4-B820-CD11-37E554C2625F}"/>
                </a:ext>
              </a:extLst>
            </p:cNvPr>
            <p:cNvSpPr txBox="1"/>
            <p:nvPr/>
          </p:nvSpPr>
          <p:spPr>
            <a:xfrm>
              <a:off x="1092048" y="3475914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/>
                <a:t>64kDa</a:t>
              </a:r>
              <a:endParaRPr lang="es-ES_tradnl" sz="1050" dirty="0"/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8F086145-EC6B-28BC-4D25-0778FCB9EEF0}"/>
                </a:ext>
              </a:extLst>
            </p:cNvPr>
            <p:cNvSpPr txBox="1"/>
            <p:nvPr/>
          </p:nvSpPr>
          <p:spPr>
            <a:xfrm>
              <a:off x="1091431" y="3811404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49kDa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6152A7AB-CF98-600D-4F02-391B0ACA5A98}"/>
                </a:ext>
              </a:extLst>
            </p:cNvPr>
            <p:cNvSpPr txBox="1"/>
            <p:nvPr/>
          </p:nvSpPr>
          <p:spPr>
            <a:xfrm>
              <a:off x="1091430" y="4198353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37kDa</a:t>
              </a:r>
            </a:p>
          </p:txBody>
        </p:sp>
        <p:pic>
          <p:nvPicPr>
            <p:cNvPr id="15" name="Imagen 14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AC8A3110-F31F-42A9-D950-E93C73AE72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3665" t="31157" r="61072" b="13893"/>
            <a:stretch/>
          </p:blipFill>
          <p:spPr>
            <a:xfrm>
              <a:off x="1753680" y="2319944"/>
              <a:ext cx="266679" cy="2692475"/>
            </a:xfrm>
            <a:prstGeom prst="rect">
              <a:avLst/>
            </a:prstGeom>
          </p:spPr>
        </p:pic>
        <p:pic>
          <p:nvPicPr>
            <p:cNvPr id="16" name="Imagen 15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D5998CB8-3D7F-A2E2-EF13-7AC62335CD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l="39656" t="30827" r="37841" b="15176"/>
            <a:stretch/>
          </p:blipFill>
          <p:spPr>
            <a:xfrm>
              <a:off x="2197567" y="2319945"/>
              <a:ext cx="1152635" cy="267442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30" name="Rectángulo 29">
            <a:extLst>
              <a:ext uri="{FF2B5EF4-FFF2-40B4-BE49-F238E27FC236}">
                <a16:creationId xmlns:a16="http://schemas.microsoft.com/office/drawing/2014/main" id="{DE39B055-CB52-BF3C-D95A-5D0CC42CD599}"/>
              </a:ext>
            </a:extLst>
          </p:cNvPr>
          <p:cNvSpPr/>
          <p:nvPr/>
        </p:nvSpPr>
        <p:spPr>
          <a:xfrm>
            <a:off x="4597711" y="2467829"/>
            <a:ext cx="1550593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87597136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35</Words>
  <Application>Microsoft Office PowerPoint</Application>
  <PresentationFormat>Panorámica</PresentationFormat>
  <Paragraphs>29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3-07-17T13:35:44Z</dcterms:created>
  <dcterms:modified xsi:type="dcterms:W3CDTF">2023-07-19T10:01:16Z</dcterms:modified>
</cp:coreProperties>
</file>